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108" y="3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8CCF4-CB0D-4E63-A009-C5063B3830D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6555A-D77B-4389-8748-F56E2F1B5B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3170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8CCF4-CB0D-4E63-A009-C5063B3830D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6555A-D77B-4389-8748-F56E2F1B5B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0042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8CCF4-CB0D-4E63-A009-C5063B3830D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6555A-D77B-4389-8748-F56E2F1B5B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8854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8CCF4-CB0D-4E63-A009-C5063B3830D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6555A-D77B-4389-8748-F56E2F1B5B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544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8CCF4-CB0D-4E63-A009-C5063B3830D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6555A-D77B-4389-8748-F56E2F1B5B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6087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8CCF4-CB0D-4E63-A009-C5063B3830D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6555A-D77B-4389-8748-F56E2F1B5B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3113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8CCF4-CB0D-4E63-A009-C5063B3830D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6555A-D77B-4389-8748-F56E2F1B5B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15598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8CCF4-CB0D-4E63-A009-C5063B3830D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6555A-D77B-4389-8748-F56E2F1B5B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54891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8CCF4-CB0D-4E63-A009-C5063B3830D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6555A-D77B-4389-8748-F56E2F1B5B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0547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8CCF4-CB0D-4E63-A009-C5063B3830D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6555A-D77B-4389-8748-F56E2F1B5B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5934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B8CCF4-CB0D-4E63-A009-C5063B3830D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6555A-D77B-4389-8748-F56E2F1B5B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7221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B8CCF4-CB0D-4E63-A009-C5063B3830D3}" type="datetimeFigureOut">
              <a:rPr lang="de-DE" smtClean="0"/>
              <a:t>07.02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6555A-D77B-4389-8748-F56E2F1B5B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7319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1816370"/>
              </p:ext>
            </p:extLst>
          </p:nvPr>
        </p:nvGraphicFramePr>
        <p:xfrm>
          <a:off x="1777999" y="1282908"/>
          <a:ext cx="7112001" cy="2276475"/>
        </p:xfrm>
        <a:graphic>
          <a:graphicData uri="http://schemas.openxmlformats.org/drawingml/2006/table">
            <a:tbl>
              <a:tblPr/>
              <a:tblGrid>
                <a:gridCol w="829045">
                  <a:extLst>
                    <a:ext uri="{9D8B030D-6E8A-4147-A177-3AD203B41FA5}">
                      <a16:colId xmlns:a16="http://schemas.microsoft.com/office/drawing/2014/main" val="3214453522"/>
                    </a:ext>
                  </a:extLst>
                </a:gridCol>
                <a:gridCol w="2048790">
                  <a:extLst>
                    <a:ext uri="{9D8B030D-6E8A-4147-A177-3AD203B41FA5}">
                      <a16:colId xmlns:a16="http://schemas.microsoft.com/office/drawing/2014/main" val="1976741239"/>
                    </a:ext>
                  </a:extLst>
                </a:gridCol>
                <a:gridCol w="775046">
                  <a:extLst>
                    <a:ext uri="{9D8B030D-6E8A-4147-A177-3AD203B41FA5}">
                      <a16:colId xmlns:a16="http://schemas.microsoft.com/office/drawing/2014/main" val="1609535848"/>
                    </a:ext>
                  </a:extLst>
                </a:gridCol>
                <a:gridCol w="762340">
                  <a:extLst>
                    <a:ext uri="{9D8B030D-6E8A-4147-A177-3AD203B41FA5}">
                      <a16:colId xmlns:a16="http://schemas.microsoft.com/office/drawing/2014/main" val="1748100708"/>
                    </a:ext>
                  </a:extLst>
                </a:gridCol>
                <a:gridCol w="771870">
                  <a:extLst>
                    <a:ext uri="{9D8B030D-6E8A-4147-A177-3AD203B41FA5}">
                      <a16:colId xmlns:a16="http://schemas.microsoft.com/office/drawing/2014/main" val="454296192"/>
                    </a:ext>
                  </a:extLst>
                </a:gridCol>
                <a:gridCol w="381170">
                  <a:extLst>
                    <a:ext uri="{9D8B030D-6E8A-4147-A177-3AD203B41FA5}">
                      <a16:colId xmlns:a16="http://schemas.microsoft.com/office/drawing/2014/main" val="898351241"/>
                    </a:ext>
                  </a:extLst>
                </a:gridCol>
                <a:gridCol w="771870">
                  <a:extLst>
                    <a:ext uri="{9D8B030D-6E8A-4147-A177-3AD203B41FA5}">
                      <a16:colId xmlns:a16="http://schemas.microsoft.com/office/drawing/2014/main" val="3232526589"/>
                    </a:ext>
                  </a:extLst>
                </a:gridCol>
                <a:gridCol w="771870">
                  <a:extLst>
                    <a:ext uri="{9D8B030D-6E8A-4147-A177-3AD203B41FA5}">
                      <a16:colId xmlns:a16="http://schemas.microsoft.com/office/drawing/2014/main" val="871902498"/>
                    </a:ext>
                  </a:extLst>
                </a:gridCol>
              </a:tblGrid>
              <a:tr h="361950"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TB case #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agnosi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abo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RP (mg/l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eukocyte number (GPT/l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2176735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livery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livery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321373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PROM; IUG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.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306762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PROM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.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.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72290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PROM; AI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.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.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35247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PRO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40259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PRO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593267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PRO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&lt;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.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.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988880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663421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UG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783897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lyhydramnio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.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7112941"/>
                  </a:ext>
                </a:extLst>
              </a:tr>
            </a:tbl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7499" y="7499"/>
            <a:ext cx="26938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Table 1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1777999" y="4170947"/>
            <a:ext cx="711200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diagnosis of the eight PTB patients, combined with information whether the patients were admitted to hospital with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labor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CRP values and leukocyte numbers at the first day of treatment with steroids to induce lung maturation (time point 1; TP1) and immediate before delivery, usually two-three days after TP1, were summarized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7222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0</Words>
  <Application>Microsoft Office PowerPoint</Application>
  <PresentationFormat>Breitbild</PresentationFormat>
  <Paragraphs>8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usse, Mandy</dc:creator>
  <cp:lastModifiedBy>Busse, Mandy</cp:lastModifiedBy>
  <cp:revision>3</cp:revision>
  <dcterms:created xsi:type="dcterms:W3CDTF">2019-12-17T12:22:22Z</dcterms:created>
  <dcterms:modified xsi:type="dcterms:W3CDTF">2020-02-07T12:30:22Z</dcterms:modified>
</cp:coreProperties>
</file>